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98" d="100"/>
          <a:sy n="98" d="100"/>
        </p:scale>
        <p:origin x="192" y="-1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634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7407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6562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6230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091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13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514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2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52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3033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644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5B947-C1C0-4090-8477-4EA0D8ED682F}" type="datetimeFigureOut">
              <a:rPr kumimoji="1" lang="ja-JP" altLang="en-US" smtClean="0"/>
              <a:t>2017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D0DE3-9A27-40E4-8134-B58B2D69E3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199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dditional file X8_ooc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74240" y="594360"/>
            <a:ext cx="4572000" cy="4572000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701040" y="6127095"/>
            <a:ext cx="80264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8: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vie S1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 images of DAPI stained chromosomes of oocyte in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2c.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39455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dditional file X8_emb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84400" y="614680"/>
            <a:ext cx="4572000" cy="4572000"/>
          </a:xfrm>
          <a:prstGeom prst="rect">
            <a:avLst/>
          </a:prstGeom>
        </p:spPr>
      </p:pic>
      <p:sp>
        <p:nvSpPr>
          <p:cNvPr id="4" name="正方形/長方形 3"/>
          <p:cNvSpPr/>
          <p:nvPr/>
        </p:nvSpPr>
        <p:spPr>
          <a:xfrm>
            <a:off x="650240" y="6266676"/>
            <a:ext cx="80264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8: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vie S2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 images of DAPI stained chromosomes of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embryo </a:t>
            </a:r>
            <a:r>
              <a:rPr lang="en-US" altLang="ja-JP" sz="16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in </a:t>
            </a:r>
            <a:r>
              <a:rPr lang="en-US" altLang="ja-JP" sz="160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2f.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5250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36</Words>
  <Application>Microsoft Office PowerPoint</Application>
  <PresentationFormat>画面に合わせる (4:3)</PresentationFormat>
  <Paragraphs>2</Paragraphs>
  <Slides>2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ji KOHARA</dc:creator>
  <cp:lastModifiedBy>Hideaki HIRAKI</cp:lastModifiedBy>
  <cp:revision>3</cp:revision>
  <dcterms:created xsi:type="dcterms:W3CDTF">2017-05-04T00:44:40Z</dcterms:created>
  <dcterms:modified xsi:type="dcterms:W3CDTF">2017-05-12T14:54:04Z</dcterms:modified>
</cp:coreProperties>
</file>